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3" d="100"/>
          <a:sy n="113" d="100"/>
        </p:scale>
        <p:origin x="155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AB1F36-C981-41DC-976D-A6DD086D1A36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4BD0CD-F4C0-458C-89F0-599CD7688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755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D21D819-F1F3-43E4-B5DC-C8FF6F94FC7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9502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167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199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709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492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086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063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322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33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440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610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560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241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/>
          </p:nvPr>
        </p:nvGraphicFramePr>
        <p:xfrm>
          <a:off x="304800" y="914400"/>
          <a:ext cx="2667000" cy="4608576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828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382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mographics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ce (N=50)</a:t>
                      </a:r>
                    </a:p>
                  </a:txBody>
                  <a:tcPr marL="9144" marR="9144" marT="9144" marB="9144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Caucasian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 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African American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der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Male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 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Female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 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(years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&lt;3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30-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 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&gt;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 </a:t>
                      </a:r>
                      <a:r>
                        <a:rPr lang="en-US" sz="1000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73152">
                <a:tc>
                  <a:txBody>
                    <a:bodyPr/>
                    <a:lstStyle/>
                    <a:p>
                      <a:pPr algn="l" fontAlgn="b"/>
                      <a:endParaRPr lang="en-US" sz="6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yroid status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yroglobulin (ng/mL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&lt;0.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0.1-2.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&gt;2.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yroglobulin Antibody (IU/mL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&lt;2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 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&gt;2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yroid</a:t>
                      </a:r>
                      <a:r>
                        <a:rPr lang="en-US" sz="1000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isease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PT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FT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Undefined T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Graves Disease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Other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No Known</a:t>
                      </a:r>
                      <a:r>
                        <a:rPr lang="en-US" sz="1000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isease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/ 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" marR="9144" marT="9144" marB="9144" anchor="b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70029" y="533400"/>
            <a:ext cx="59169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upplemental Table 1: </a:t>
            </a:r>
            <a:r>
              <a:rPr lang="en-US" sz="1400" dirty="0"/>
              <a:t>Subject socio-demographics and clinical characteristics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09239" y="5562600"/>
            <a:ext cx="182453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TC: papillary thyroid cancer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TC: follicular thyroid cancer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C: thyroid cancer</a:t>
            </a:r>
          </a:p>
        </p:txBody>
      </p:sp>
    </p:spTree>
    <p:extLst>
      <p:ext uri="{BB962C8B-B14F-4D97-AF65-F5344CB8AC3E}">
        <p14:creationId xmlns:p14="http://schemas.microsoft.com/office/powerpoint/2010/main" val="73956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6</TotalTime>
  <Words>148</Words>
  <Application>Microsoft Office PowerPoint</Application>
  <PresentationFormat>On-screen Show (4:3)</PresentationFormat>
  <Paragraphs>4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Work</dc:creator>
  <cp:lastModifiedBy>Wheeler, Sarah</cp:lastModifiedBy>
  <cp:revision>21</cp:revision>
  <dcterms:created xsi:type="dcterms:W3CDTF">2014-07-31T18:58:44Z</dcterms:created>
  <dcterms:modified xsi:type="dcterms:W3CDTF">2017-12-06T21:43:34Z</dcterms:modified>
</cp:coreProperties>
</file>